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3936" y="-13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2\qPCR%20results%20for%20GraphPad%20-%20CM%20Titrations%20-%20v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2\qPCR%20results%20for%20GraphPad%20-%20CM%20Titrations%20-%20v0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2\qPCR%20results%20for%20GraphPad%20-%20CM%20Titrations%20-%20v0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Z%20-%20FIGURES%20for%20211%20PAPER\SUPP.%20FIGURE%2002\qPCR%20results%20for%20GraphPad%20-%20CM%20Titrations%20-%20v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Targets Normed GRAPHS'!$P$4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20000"/>
                  <a:lumOff val="8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C$7:$C$9</c:f>
                <c:numCache>
                  <c:formatCode>General</c:formatCode>
                  <c:ptCount val="3"/>
                  <c:pt idx="0">
                    <c:v>0.10116915397128552</c:v>
                  </c:pt>
                  <c:pt idx="1">
                    <c:v>0.10579767605589618</c:v>
                  </c:pt>
                  <c:pt idx="2">
                    <c:v>0.15811565390346174</c:v>
                  </c:pt>
                </c:numCache>
              </c:numRef>
            </c:plus>
            <c:minus>
              <c:numRef>
                <c:f>'Targets Normed GRAPHS'!$C$7:$C$9</c:f>
                <c:numCache>
                  <c:formatCode>General</c:formatCode>
                  <c:ptCount val="3"/>
                  <c:pt idx="0">
                    <c:v>0.10116915397128552</c:v>
                  </c:pt>
                  <c:pt idx="1">
                    <c:v>0.10579767605589618</c:v>
                  </c:pt>
                  <c:pt idx="2">
                    <c:v>0.15811565390346174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B$7:$B$9</c:f>
              <c:numCache>
                <c:formatCode>0.00</c:formatCode>
                <c:ptCount val="3"/>
                <c:pt idx="0">
                  <c:v>0.34852299316001217</c:v>
                </c:pt>
                <c:pt idx="1">
                  <c:v>0.44075949226541666</c:v>
                </c:pt>
                <c:pt idx="2">
                  <c:v>0.82170297580194118</c:v>
                </c:pt>
              </c:numCache>
            </c:numRef>
          </c:val>
        </c:ser>
        <c:ser>
          <c:idx val="3"/>
          <c:order val="1"/>
          <c:tx>
            <c:strRef>
              <c:f>'Targets Normed GRAPHS'!$P$6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C$15:$C$17</c:f>
                <c:numCache>
                  <c:formatCode>General</c:formatCode>
                  <c:ptCount val="3"/>
                  <c:pt idx="0">
                    <c:v>6.0412050947379295E-2</c:v>
                  </c:pt>
                  <c:pt idx="1">
                    <c:v>0.1165341497919109</c:v>
                  </c:pt>
                  <c:pt idx="2">
                    <c:v>6.9147247858552932E-2</c:v>
                  </c:pt>
                </c:numCache>
              </c:numRef>
            </c:plus>
            <c:minus>
              <c:numRef>
                <c:f>'Targets Normed GRAPHS'!$C$15:$C$17</c:f>
                <c:numCache>
                  <c:formatCode>General</c:formatCode>
                  <c:ptCount val="3"/>
                  <c:pt idx="0">
                    <c:v>6.0412050947379295E-2</c:v>
                  </c:pt>
                  <c:pt idx="1">
                    <c:v>0.1165341497919109</c:v>
                  </c:pt>
                  <c:pt idx="2">
                    <c:v>6.9147247858552932E-2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B$15:$B$17</c:f>
              <c:numCache>
                <c:formatCode>0.00</c:formatCode>
                <c:ptCount val="3"/>
                <c:pt idx="0">
                  <c:v>0.26179665660367024</c:v>
                </c:pt>
                <c:pt idx="1">
                  <c:v>0.41731605328406296</c:v>
                </c:pt>
                <c:pt idx="2">
                  <c:v>0.86423842351738955</c:v>
                </c:pt>
              </c:numCache>
            </c:numRef>
          </c:val>
        </c:ser>
        <c:ser>
          <c:idx val="5"/>
          <c:order val="2"/>
          <c:tx>
            <c:strRef>
              <c:f>'Targets Normed GRAPHS'!$P$8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rgbClr val="00206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C$23:$C$25</c:f>
                <c:numCache>
                  <c:formatCode>General</c:formatCode>
                  <c:ptCount val="3"/>
                  <c:pt idx="0">
                    <c:v>7.7132990835329193E-2</c:v>
                  </c:pt>
                  <c:pt idx="1">
                    <c:v>7.9347536439017194E-2</c:v>
                  </c:pt>
                  <c:pt idx="2">
                    <c:v>6.4471729407777234E-2</c:v>
                  </c:pt>
                </c:numCache>
              </c:numRef>
            </c:plus>
            <c:minus>
              <c:numRef>
                <c:f>'Targets Normed GRAPHS'!$C$23:$C$25</c:f>
                <c:numCache>
                  <c:formatCode>General</c:formatCode>
                  <c:ptCount val="3"/>
                  <c:pt idx="0">
                    <c:v>7.7132990835329193E-2</c:v>
                  </c:pt>
                  <c:pt idx="1">
                    <c:v>7.9347536439017194E-2</c:v>
                  </c:pt>
                  <c:pt idx="2">
                    <c:v>6.4471729407777234E-2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B$23:$B$25</c:f>
              <c:numCache>
                <c:formatCode>0.00</c:formatCode>
                <c:ptCount val="3"/>
                <c:pt idx="0">
                  <c:v>0.25790186232024914</c:v>
                </c:pt>
                <c:pt idx="1">
                  <c:v>0.48273431752629026</c:v>
                </c:pt>
                <c:pt idx="2">
                  <c:v>0.915379418491332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583232"/>
        <c:axId val="96436608"/>
      </c:barChart>
      <c:catAx>
        <c:axId val="955832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96436608"/>
        <c:crosses val="autoZero"/>
        <c:auto val="1"/>
        <c:lblAlgn val="ctr"/>
        <c:lblOffset val="100"/>
        <c:noMultiLvlLbl val="0"/>
      </c:catAx>
      <c:valAx>
        <c:axId val="9643660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955832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436881894823758E-2"/>
          <c:y val="0.13139350834011287"/>
          <c:w val="0.88124151978310594"/>
          <c:h val="0.67157104488762953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Targets Normed GRAPHS'!$P$4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F$7:$F$9</c:f>
                <c:numCache>
                  <c:formatCode>General</c:formatCode>
                  <c:ptCount val="3"/>
                  <c:pt idx="0">
                    <c:v>0.18038609937998731</c:v>
                  </c:pt>
                  <c:pt idx="1">
                    <c:v>0.27024536597200288</c:v>
                  </c:pt>
                  <c:pt idx="2">
                    <c:v>0.3149544108350249</c:v>
                  </c:pt>
                </c:numCache>
              </c:numRef>
            </c:plus>
            <c:minus>
              <c:numRef>
                <c:f>'Targets Normed GRAPHS'!$F$7:$F$9</c:f>
                <c:numCache>
                  <c:formatCode>General</c:formatCode>
                  <c:ptCount val="3"/>
                  <c:pt idx="0">
                    <c:v>0.18038609937998731</c:v>
                  </c:pt>
                  <c:pt idx="1">
                    <c:v>0.27024536597200288</c:v>
                  </c:pt>
                  <c:pt idx="2">
                    <c:v>0.3149544108350249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E$7:$E$9</c:f>
              <c:numCache>
                <c:formatCode>0.00</c:formatCode>
                <c:ptCount val="3"/>
                <c:pt idx="0">
                  <c:v>0.36624030700403731</c:v>
                </c:pt>
                <c:pt idx="1">
                  <c:v>0.53971629004648369</c:v>
                </c:pt>
                <c:pt idx="2">
                  <c:v>0.89047069017852165</c:v>
                </c:pt>
              </c:numCache>
            </c:numRef>
          </c:val>
        </c:ser>
        <c:ser>
          <c:idx val="3"/>
          <c:order val="1"/>
          <c:tx>
            <c:strRef>
              <c:f>'Targets Normed GRAPHS'!$P$6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F$15:$F$17</c:f>
                <c:numCache>
                  <c:formatCode>General</c:formatCode>
                  <c:ptCount val="3"/>
                  <c:pt idx="0">
                    <c:v>0.16036282722599832</c:v>
                  </c:pt>
                  <c:pt idx="1">
                    <c:v>0.20819414902243863</c:v>
                  </c:pt>
                  <c:pt idx="2">
                    <c:v>0.28674221046536313</c:v>
                  </c:pt>
                </c:numCache>
              </c:numRef>
            </c:plus>
            <c:minus>
              <c:numRef>
                <c:f>'Targets Normed GRAPHS'!$F$15:$F$17</c:f>
                <c:numCache>
                  <c:formatCode>General</c:formatCode>
                  <c:ptCount val="3"/>
                  <c:pt idx="0">
                    <c:v>0.16036282722599832</c:v>
                  </c:pt>
                  <c:pt idx="1">
                    <c:v>0.20819414902243863</c:v>
                  </c:pt>
                  <c:pt idx="2">
                    <c:v>0.28674221046536313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E$15:$E$17</c:f>
              <c:numCache>
                <c:formatCode>0.00</c:formatCode>
                <c:ptCount val="3"/>
                <c:pt idx="0">
                  <c:v>0.31248786812147994</c:v>
                </c:pt>
                <c:pt idx="1">
                  <c:v>0.46898982776123782</c:v>
                </c:pt>
                <c:pt idx="2">
                  <c:v>0.85997540361620484</c:v>
                </c:pt>
              </c:numCache>
            </c:numRef>
          </c:val>
        </c:ser>
        <c:ser>
          <c:idx val="5"/>
          <c:order val="2"/>
          <c:tx>
            <c:strRef>
              <c:f>'Targets Normed GRAPHS'!$P$8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rgbClr val="00206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F$23:$F$25</c:f>
                <c:numCache>
                  <c:formatCode>General</c:formatCode>
                  <c:ptCount val="3"/>
                  <c:pt idx="0">
                    <c:v>0.12490180018214811</c:v>
                  </c:pt>
                  <c:pt idx="1">
                    <c:v>0.24729697551014124</c:v>
                  </c:pt>
                  <c:pt idx="2">
                    <c:v>0.12065002646488222</c:v>
                  </c:pt>
                </c:numCache>
              </c:numRef>
            </c:plus>
            <c:minus>
              <c:numRef>
                <c:f>'Targets Normed GRAPHS'!$F$23:$F$25</c:f>
                <c:numCache>
                  <c:formatCode>General</c:formatCode>
                  <c:ptCount val="3"/>
                  <c:pt idx="0">
                    <c:v>0.12490180018214811</c:v>
                  </c:pt>
                  <c:pt idx="1">
                    <c:v>0.24729697551014124</c:v>
                  </c:pt>
                  <c:pt idx="2">
                    <c:v>0.12065002646488222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E$23:$E$25</c:f>
              <c:numCache>
                <c:formatCode>0.00</c:formatCode>
                <c:ptCount val="3"/>
                <c:pt idx="0">
                  <c:v>0.2881360315471157</c:v>
                </c:pt>
                <c:pt idx="1">
                  <c:v>0.64852264331845755</c:v>
                </c:pt>
                <c:pt idx="2">
                  <c:v>0.933881574894528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098816"/>
        <c:axId val="100529664"/>
      </c:barChart>
      <c:catAx>
        <c:axId val="1000988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100529664"/>
        <c:crosses val="autoZero"/>
        <c:auto val="1"/>
        <c:lblAlgn val="ctr"/>
        <c:lblOffset val="100"/>
        <c:noMultiLvlLbl val="0"/>
      </c:catAx>
      <c:valAx>
        <c:axId val="100529664"/>
        <c:scaling>
          <c:orientation val="minMax"/>
          <c:max val="1.2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100098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Targets Normed GRAPHS'!$P$4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I$7:$I$9</c:f>
                <c:numCache>
                  <c:formatCode>General</c:formatCode>
                  <c:ptCount val="3"/>
                  <c:pt idx="0">
                    <c:v>5.7451088765670386E-2</c:v>
                  </c:pt>
                  <c:pt idx="1">
                    <c:v>5.3701392969517987E-2</c:v>
                  </c:pt>
                  <c:pt idx="2">
                    <c:v>0.17438700520359157</c:v>
                  </c:pt>
                </c:numCache>
              </c:numRef>
            </c:plus>
            <c:minus>
              <c:numRef>
                <c:f>'Targets Normed GRAPHS'!$I$7:$I$9</c:f>
                <c:numCache>
                  <c:formatCode>General</c:formatCode>
                  <c:ptCount val="3"/>
                  <c:pt idx="0">
                    <c:v>5.7451088765670386E-2</c:v>
                  </c:pt>
                  <c:pt idx="1">
                    <c:v>5.3701392969517987E-2</c:v>
                  </c:pt>
                  <c:pt idx="2">
                    <c:v>0.17438700520359157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H$7:$H$9</c:f>
              <c:numCache>
                <c:formatCode>0.00</c:formatCode>
                <c:ptCount val="3"/>
                <c:pt idx="0">
                  <c:v>0.52662225285127173</c:v>
                </c:pt>
                <c:pt idx="1">
                  <c:v>0.5038346852235317</c:v>
                </c:pt>
                <c:pt idx="2">
                  <c:v>0.90967071882823369</c:v>
                </c:pt>
              </c:numCache>
            </c:numRef>
          </c:val>
        </c:ser>
        <c:ser>
          <c:idx val="3"/>
          <c:order val="1"/>
          <c:tx>
            <c:strRef>
              <c:f>'Targets Normed GRAPHS'!$P$6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I$15:$I$17</c:f>
                <c:numCache>
                  <c:formatCode>General</c:formatCode>
                  <c:ptCount val="3"/>
                  <c:pt idx="0">
                    <c:v>6.2359300197480518E-2</c:v>
                  </c:pt>
                  <c:pt idx="1">
                    <c:v>7.4641905385113741E-2</c:v>
                  </c:pt>
                  <c:pt idx="2">
                    <c:v>7.9532110338819531E-2</c:v>
                  </c:pt>
                </c:numCache>
              </c:numRef>
            </c:plus>
            <c:minus>
              <c:numRef>
                <c:f>'Targets Normed GRAPHS'!$I$15:$I$17</c:f>
                <c:numCache>
                  <c:formatCode>General</c:formatCode>
                  <c:ptCount val="3"/>
                  <c:pt idx="0">
                    <c:v>6.2359300197480518E-2</c:v>
                  </c:pt>
                  <c:pt idx="1">
                    <c:v>7.4641905385113741E-2</c:v>
                  </c:pt>
                  <c:pt idx="2">
                    <c:v>7.9532110338819531E-2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H$15:$H$17</c:f>
              <c:numCache>
                <c:formatCode>0.00</c:formatCode>
                <c:ptCount val="3"/>
                <c:pt idx="0">
                  <c:v>0.4870303583910176</c:v>
                </c:pt>
                <c:pt idx="1">
                  <c:v>0.5709485029756497</c:v>
                </c:pt>
                <c:pt idx="2">
                  <c:v>0.86427584932765766</c:v>
                </c:pt>
              </c:numCache>
            </c:numRef>
          </c:val>
        </c:ser>
        <c:ser>
          <c:idx val="5"/>
          <c:order val="2"/>
          <c:tx>
            <c:strRef>
              <c:f>'Targets Normed GRAPHS'!$P$8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rgbClr val="00206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Targets Normed GRAPHS'!$I$23:$I$25</c:f>
                <c:numCache>
                  <c:formatCode>General</c:formatCode>
                  <c:ptCount val="3"/>
                  <c:pt idx="0">
                    <c:v>8.7275762606257232E-2</c:v>
                  </c:pt>
                  <c:pt idx="1">
                    <c:v>9.8852314947482797E-2</c:v>
                  </c:pt>
                  <c:pt idx="2">
                    <c:v>2.8242740018055018E-2</c:v>
                  </c:pt>
                </c:numCache>
              </c:numRef>
            </c:plus>
            <c:minus>
              <c:numRef>
                <c:f>'Targets Normed GRAPHS'!$I$23:$I$25</c:f>
                <c:numCache>
                  <c:formatCode>General</c:formatCode>
                  <c:ptCount val="3"/>
                  <c:pt idx="0">
                    <c:v>8.7275762606257232E-2</c:v>
                  </c:pt>
                  <c:pt idx="1">
                    <c:v>9.8852314947482797E-2</c:v>
                  </c:pt>
                  <c:pt idx="2">
                    <c:v>2.8242740018055018E-2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'Targets Normed GRAPHS'!$H$23:$H$25</c:f>
              <c:numCache>
                <c:formatCode>0.00</c:formatCode>
                <c:ptCount val="3"/>
                <c:pt idx="0">
                  <c:v>0.4288578889724477</c:v>
                </c:pt>
                <c:pt idx="1">
                  <c:v>0.54391821316799804</c:v>
                </c:pt>
                <c:pt idx="2">
                  <c:v>0.92501724597794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525632"/>
        <c:axId val="105527168"/>
      </c:barChart>
      <c:catAx>
        <c:axId val="1055256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105527168"/>
        <c:crosses val="autoZero"/>
        <c:auto val="1"/>
        <c:lblAlgn val="ctr"/>
        <c:lblOffset val="100"/>
        <c:noMultiLvlLbl val="0"/>
      </c:catAx>
      <c:valAx>
        <c:axId val="105527168"/>
        <c:scaling>
          <c:orientation val="minMax"/>
          <c:max val="1.2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1055256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err="1" smtClean="0"/>
              <a:t>miR</a:t>
            </a:r>
            <a:r>
              <a:rPr lang="en-US" sz="1200" smtClean="0"/>
              <a:t>-211 </a:t>
            </a:r>
            <a:r>
              <a:rPr lang="en-US" sz="1200" dirty="0"/>
              <a:t>Mimic Titration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211M Tracking'!$F$18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211M Tracking'!$H$13;'211M Tracking'!$N$13;'211M Tracking'!$T$13)</c:f>
                <c:numCache>
                  <c:formatCode>General</c:formatCode>
                  <c:ptCount val="3"/>
                  <c:pt idx="0">
                    <c:v>6721.8646935934257</c:v>
                  </c:pt>
                  <c:pt idx="1">
                    <c:v>330.44150280158675</c:v>
                  </c:pt>
                  <c:pt idx="2">
                    <c:v>109.56687394223789</c:v>
                  </c:pt>
                </c:numCache>
              </c:numRef>
            </c:plus>
            <c:minus>
              <c:numRef>
                <c:f>('211M Tracking'!$H$13;'211M Tracking'!$N$13;'211M Tracking'!$T$13)</c:f>
                <c:numCache>
                  <c:formatCode>General</c:formatCode>
                  <c:ptCount val="3"/>
                  <c:pt idx="0">
                    <c:v>6721.8646935934257</c:v>
                  </c:pt>
                  <c:pt idx="1">
                    <c:v>330.44150280158675</c:v>
                  </c:pt>
                  <c:pt idx="2">
                    <c:v>109.56687394223789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('211M Tracking'!$H$10;'211M Tracking'!$N$10;'211M Tracking'!$T$10)</c:f>
              <c:numCache>
                <c:formatCode>0.00</c:formatCode>
                <c:ptCount val="3"/>
                <c:pt idx="0">
                  <c:v>25239.679995965882</c:v>
                </c:pt>
                <c:pt idx="1">
                  <c:v>4726.9886071872461</c:v>
                </c:pt>
                <c:pt idx="2">
                  <c:v>938.95534207854303</c:v>
                </c:pt>
              </c:numCache>
            </c:numRef>
          </c:val>
        </c:ser>
        <c:ser>
          <c:idx val="3"/>
          <c:order val="1"/>
          <c:tx>
            <c:strRef>
              <c:f>'211M Tracking'!$F$19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211M Tracking'!$J$13;'211M Tracking'!$P$13;'211M Tracking'!$V$13)</c:f>
                <c:numCache>
                  <c:formatCode>General</c:formatCode>
                  <c:ptCount val="3"/>
                  <c:pt idx="0">
                    <c:v>4777.327119249423</c:v>
                  </c:pt>
                  <c:pt idx="1">
                    <c:v>275.84116078310831</c:v>
                  </c:pt>
                  <c:pt idx="2">
                    <c:v>83.117549007186099</c:v>
                  </c:pt>
                </c:numCache>
              </c:numRef>
            </c:plus>
            <c:minus>
              <c:numRef>
                <c:f>('211M Tracking'!$J$13;'211M Tracking'!$P$13;'211M Tracking'!$V$13)</c:f>
                <c:numCache>
                  <c:formatCode>General</c:formatCode>
                  <c:ptCount val="3"/>
                  <c:pt idx="0">
                    <c:v>4777.327119249423</c:v>
                  </c:pt>
                  <c:pt idx="1">
                    <c:v>275.84116078310831</c:v>
                  </c:pt>
                  <c:pt idx="2">
                    <c:v>83.117549007186099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('211M Tracking'!$J$10;'211M Tracking'!$P$10;'211M Tracking'!$V$10)</c:f>
              <c:numCache>
                <c:formatCode>0.00</c:formatCode>
                <c:ptCount val="3"/>
                <c:pt idx="0">
                  <c:v>11993.167701621807</c:v>
                </c:pt>
                <c:pt idx="1">
                  <c:v>2004.856107850168</c:v>
                </c:pt>
                <c:pt idx="2">
                  <c:v>338.95113448678347</c:v>
                </c:pt>
              </c:numCache>
            </c:numRef>
          </c:val>
        </c:ser>
        <c:ser>
          <c:idx val="5"/>
          <c:order val="2"/>
          <c:tx>
            <c:strRef>
              <c:f>'211M Tracking'!$F$20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rgbClr val="00206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211M Tracking'!$L$13;'211M Tracking'!$R$13;'211M Tracking'!$X$13)</c:f>
                <c:numCache>
                  <c:formatCode>General</c:formatCode>
                  <c:ptCount val="3"/>
                  <c:pt idx="0">
                    <c:v>538.24654479587446</c:v>
                  </c:pt>
                  <c:pt idx="1">
                    <c:v>109.28055671981694</c:v>
                  </c:pt>
                  <c:pt idx="2">
                    <c:v>34.643881771637211</c:v>
                  </c:pt>
                </c:numCache>
              </c:numRef>
            </c:plus>
            <c:minus>
              <c:numRef>
                <c:f>('211M Tracking'!$L$13;'211M Tracking'!$R$13;'211M Tracking'!$X$13)</c:f>
                <c:numCache>
                  <c:formatCode>General</c:formatCode>
                  <c:ptCount val="3"/>
                  <c:pt idx="0">
                    <c:v>538.24654479587446</c:v>
                  </c:pt>
                  <c:pt idx="1">
                    <c:v>109.28055671981694</c:v>
                  </c:pt>
                  <c:pt idx="2">
                    <c:v>34.643881771637211</c:v>
                  </c:pt>
                </c:numCache>
              </c:numRef>
            </c:minus>
          </c:errBars>
          <c:cat>
            <c:strRef>
              <c:f>'Targets Normed GRAPHS'!$O$3:$O$5</c:f>
              <c:strCache>
                <c:ptCount val="3"/>
                <c:pt idx="0">
                  <c:v>50nM</c:v>
                </c:pt>
                <c:pt idx="1">
                  <c:v>5nM</c:v>
                </c:pt>
                <c:pt idx="2">
                  <c:v>0,5nM</c:v>
                </c:pt>
              </c:strCache>
            </c:strRef>
          </c:cat>
          <c:val>
            <c:numRef>
              <c:f>('211M Tracking'!$L$10;'211M Tracking'!$R$10;'211M Tracking'!$X$10)</c:f>
              <c:numCache>
                <c:formatCode>0.00</c:formatCode>
                <c:ptCount val="3"/>
                <c:pt idx="0">
                  <c:v>3839.2371691540848</c:v>
                </c:pt>
                <c:pt idx="1">
                  <c:v>1139.6385213496201</c:v>
                </c:pt>
                <c:pt idx="2">
                  <c:v>94.8699314025303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3602432"/>
        <c:axId val="123604352"/>
      </c:barChart>
      <c:catAx>
        <c:axId val="1236024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 b="1"/>
            </a:pPr>
            <a:endParaRPr lang="en-US"/>
          </a:p>
        </c:txPr>
        <c:crossAx val="123604352"/>
        <c:crosses val="autoZero"/>
        <c:auto val="1"/>
        <c:lblAlgn val="ctr"/>
        <c:lblOffset val="100"/>
        <c:noMultiLvlLbl val="0"/>
      </c:catAx>
      <c:valAx>
        <c:axId val="12360435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 b="1"/>
            </a:pPr>
            <a:endParaRPr lang="en-US"/>
          </a:p>
        </c:txPr>
        <c:crossAx val="123602432"/>
        <c:crosses val="autoZero"/>
        <c:crossBetween val="between"/>
      </c:valAx>
    </c:plotArea>
    <c:legend>
      <c:legendPos val="b"/>
      <c:layout/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0A8E7-62DF-4FED-B4E1-D5FE8CFE8664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AF351-FF7E-4515-82E0-BA166743881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1" name="Group 160"/>
          <p:cNvGrpSpPr/>
          <p:nvPr/>
        </p:nvGrpSpPr>
        <p:grpSpPr>
          <a:xfrm>
            <a:off x="166923" y="512117"/>
            <a:ext cx="6564078" cy="7874804"/>
            <a:chOff x="166923" y="512117"/>
            <a:chExt cx="6564078" cy="7874804"/>
          </a:xfrm>
        </p:grpSpPr>
        <p:graphicFrame>
          <p:nvGraphicFramePr>
            <p:cNvPr id="53" name="Chart 52"/>
            <p:cNvGraphicFramePr/>
            <p:nvPr>
              <p:extLst>
                <p:ext uri="{D42A27DB-BD31-4B8C-83A1-F6EECF244321}">
                  <p14:modId xmlns:p14="http://schemas.microsoft.com/office/powerpoint/2010/main" val="3109522936"/>
                </p:ext>
              </p:extLst>
            </p:nvPr>
          </p:nvGraphicFramePr>
          <p:xfrm>
            <a:off x="260350" y="4584700"/>
            <a:ext cx="2374900" cy="18986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4" name="TextBox 43"/>
            <p:cNvSpPr txBox="1"/>
            <p:nvPr/>
          </p:nvSpPr>
          <p:spPr>
            <a:xfrm>
              <a:off x="600110" y="5448762"/>
              <a:ext cx="282924" cy="19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cxnSp>
          <p:nvCxnSpPr>
            <p:cNvPr id="55" name="Straight Connector 54"/>
            <p:cNvCxnSpPr/>
            <p:nvPr/>
          </p:nvCxnSpPr>
          <p:spPr>
            <a:xfrm flipV="1">
              <a:off x="511838" y="4972050"/>
              <a:ext cx="1964662" cy="407"/>
            </a:xfrm>
            <a:prstGeom prst="line">
              <a:avLst/>
            </a:prstGeom>
            <a:ln w="3175">
              <a:solidFill>
                <a:schemeClr val="tx1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43"/>
            <p:cNvSpPr txBox="1"/>
            <p:nvPr/>
          </p:nvSpPr>
          <p:spPr>
            <a:xfrm>
              <a:off x="744591" y="5588284"/>
              <a:ext cx="282924" cy="19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58" name="TextBox 43"/>
            <p:cNvSpPr txBox="1"/>
            <p:nvPr/>
          </p:nvSpPr>
          <p:spPr>
            <a:xfrm>
              <a:off x="895421" y="5562884"/>
              <a:ext cx="282924" cy="19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59" name="TextBox 43"/>
            <p:cNvSpPr txBox="1"/>
            <p:nvPr/>
          </p:nvSpPr>
          <p:spPr>
            <a:xfrm>
              <a:off x="1234553" y="5339774"/>
              <a:ext cx="282924" cy="19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60" name="TextBox 43"/>
            <p:cNvSpPr txBox="1"/>
            <p:nvPr/>
          </p:nvSpPr>
          <p:spPr>
            <a:xfrm>
              <a:off x="1391733" y="5363958"/>
              <a:ext cx="282924" cy="19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61" name="TextBox 43"/>
            <p:cNvSpPr txBox="1"/>
            <p:nvPr/>
          </p:nvSpPr>
          <p:spPr>
            <a:xfrm>
              <a:off x="1875346" y="4730119"/>
              <a:ext cx="282924" cy="19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62" name="TextBox 43"/>
            <p:cNvSpPr txBox="1"/>
            <p:nvPr/>
          </p:nvSpPr>
          <p:spPr>
            <a:xfrm>
              <a:off x="1504463" y="5306289"/>
              <a:ext cx="4005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**</a:t>
              </a:r>
            </a:p>
          </p:txBody>
        </p:sp>
        <p:sp>
          <p:nvSpPr>
            <p:cNvPr id="63" name="TextBox 43"/>
            <p:cNvSpPr txBox="1"/>
            <p:nvPr/>
          </p:nvSpPr>
          <p:spPr>
            <a:xfrm>
              <a:off x="2019825" y="4775785"/>
              <a:ext cx="3741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64" name="TextBox 43"/>
            <p:cNvSpPr txBox="1"/>
            <p:nvPr/>
          </p:nvSpPr>
          <p:spPr>
            <a:xfrm>
              <a:off x="2189705" y="4712285"/>
              <a:ext cx="3693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graphicFrame>
          <p:nvGraphicFramePr>
            <p:cNvPr id="66" name="Chart 6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9955472"/>
                </p:ext>
              </p:extLst>
            </p:nvPr>
          </p:nvGraphicFramePr>
          <p:xfrm>
            <a:off x="2519512" y="4497885"/>
            <a:ext cx="2211238" cy="21378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67" name="Straight Connector 66"/>
            <p:cNvCxnSpPr/>
            <p:nvPr/>
          </p:nvCxnSpPr>
          <p:spPr>
            <a:xfrm>
              <a:off x="2768267" y="5010255"/>
              <a:ext cx="1873583" cy="6245"/>
            </a:xfrm>
            <a:prstGeom prst="line">
              <a:avLst/>
            </a:prstGeom>
            <a:ln w="3175">
              <a:solidFill>
                <a:schemeClr val="tx1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43"/>
            <p:cNvSpPr txBox="1"/>
            <p:nvPr/>
          </p:nvSpPr>
          <p:spPr>
            <a:xfrm>
              <a:off x="2929017" y="5399814"/>
              <a:ext cx="4618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69" name="TextBox 43"/>
            <p:cNvSpPr txBox="1"/>
            <p:nvPr/>
          </p:nvSpPr>
          <p:spPr>
            <a:xfrm>
              <a:off x="4259339" y="4598825"/>
              <a:ext cx="471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70" name="TextBox 43"/>
            <p:cNvSpPr txBox="1"/>
            <p:nvPr/>
          </p:nvSpPr>
          <p:spPr>
            <a:xfrm>
              <a:off x="4376883" y="4731735"/>
              <a:ext cx="4935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71" name="TextBox 43"/>
            <p:cNvSpPr txBox="1"/>
            <p:nvPr/>
          </p:nvSpPr>
          <p:spPr>
            <a:xfrm>
              <a:off x="2792425" y="5330185"/>
              <a:ext cx="5540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**</a:t>
              </a:r>
            </a:p>
          </p:txBody>
        </p:sp>
        <p:sp>
          <p:nvSpPr>
            <p:cNvPr id="72" name="TextBox 43"/>
            <p:cNvSpPr txBox="1"/>
            <p:nvPr/>
          </p:nvSpPr>
          <p:spPr>
            <a:xfrm>
              <a:off x="3413135" y="5054265"/>
              <a:ext cx="4349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**</a:t>
              </a:r>
            </a:p>
          </p:txBody>
        </p:sp>
        <p:sp>
          <p:nvSpPr>
            <p:cNvPr id="73" name="TextBox 43"/>
            <p:cNvSpPr txBox="1"/>
            <p:nvPr/>
          </p:nvSpPr>
          <p:spPr>
            <a:xfrm>
              <a:off x="3091012" y="5507324"/>
              <a:ext cx="280158" cy="1729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74" name="TextBox 43"/>
            <p:cNvSpPr txBox="1"/>
            <p:nvPr/>
          </p:nvSpPr>
          <p:spPr>
            <a:xfrm>
              <a:off x="3600529" y="5186955"/>
              <a:ext cx="280158" cy="1729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75" name="TextBox 43"/>
            <p:cNvSpPr txBox="1"/>
            <p:nvPr/>
          </p:nvSpPr>
          <p:spPr>
            <a:xfrm>
              <a:off x="3756172" y="4984855"/>
              <a:ext cx="280158" cy="1729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76" name="TextBox 43"/>
            <p:cNvSpPr txBox="1"/>
            <p:nvPr/>
          </p:nvSpPr>
          <p:spPr>
            <a:xfrm>
              <a:off x="4115774" y="4605175"/>
              <a:ext cx="280158" cy="1729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*</a:t>
              </a:r>
              <a:endParaRPr lang="en-US" sz="1000" dirty="0"/>
            </a:p>
          </p:txBody>
        </p:sp>
        <p:graphicFrame>
          <p:nvGraphicFramePr>
            <p:cNvPr id="78" name="Chart 7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02809072"/>
                </p:ext>
              </p:extLst>
            </p:nvPr>
          </p:nvGraphicFramePr>
          <p:xfrm>
            <a:off x="4699001" y="4584700"/>
            <a:ext cx="2032000" cy="1905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79" name="Straight Connector 78"/>
            <p:cNvCxnSpPr/>
            <p:nvPr/>
          </p:nvCxnSpPr>
          <p:spPr>
            <a:xfrm flipV="1">
              <a:off x="5067300" y="4970435"/>
              <a:ext cx="1580584" cy="1615"/>
            </a:xfrm>
            <a:prstGeom prst="line">
              <a:avLst/>
            </a:prstGeom>
            <a:ln w="3175">
              <a:solidFill>
                <a:schemeClr val="tx1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43"/>
            <p:cNvSpPr txBox="1"/>
            <p:nvPr/>
          </p:nvSpPr>
          <p:spPr>
            <a:xfrm>
              <a:off x="5526602" y="5322753"/>
              <a:ext cx="366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81" name="TextBox 43"/>
            <p:cNvSpPr txBox="1"/>
            <p:nvPr/>
          </p:nvSpPr>
          <p:spPr>
            <a:xfrm>
              <a:off x="6055493" y="4650379"/>
              <a:ext cx="364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85" name="TextBox 43"/>
            <p:cNvSpPr txBox="1"/>
            <p:nvPr/>
          </p:nvSpPr>
          <p:spPr>
            <a:xfrm>
              <a:off x="6173098" y="4773782"/>
              <a:ext cx="4055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87" name="TextBox 43"/>
            <p:cNvSpPr txBox="1"/>
            <p:nvPr/>
          </p:nvSpPr>
          <p:spPr>
            <a:xfrm>
              <a:off x="6309753" y="4786482"/>
              <a:ext cx="3640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ns</a:t>
              </a:r>
            </a:p>
          </p:txBody>
        </p:sp>
        <p:sp>
          <p:nvSpPr>
            <p:cNvPr id="88" name="TextBox 43"/>
            <p:cNvSpPr txBox="1"/>
            <p:nvPr/>
          </p:nvSpPr>
          <p:spPr>
            <a:xfrm>
              <a:off x="5656907" y="5252391"/>
              <a:ext cx="3374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**</a:t>
              </a:r>
            </a:p>
          </p:txBody>
        </p:sp>
        <p:sp>
          <p:nvSpPr>
            <p:cNvPr id="91" name="TextBox 43"/>
            <p:cNvSpPr txBox="1"/>
            <p:nvPr/>
          </p:nvSpPr>
          <p:spPr>
            <a:xfrm>
              <a:off x="5035811" y="5284653"/>
              <a:ext cx="234549" cy="197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92" name="TextBox 43"/>
            <p:cNvSpPr txBox="1"/>
            <p:nvPr/>
          </p:nvSpPr>
          <p:spPr>
            <a:xfrm>
              <a:off x="5166115" y="5342314"/>
              <a:ext cx="234549" cy="197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95" name="TextBox 43"/>
            <p:cNvSpPr txBox="1"/>
            <p:nvPr/>
          </p:nvSpPr>
          <p:spPr>
            <a:xfrm>
              <a:off x="5296420" y="5375795"/>
              <a:ext cx="234549" cy="197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110" name="TextBox 43"/>
            <p:cNvSpPr txBox="1"/>
            <p:nvPr/>
          </p:nvSpPr>
          <p:spPr>
            <a:xfrm>
              <a:off x="5800572" y="5201591"/>
              <a:ext cx="234549" cy="197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*</a:t>
              </a:r>
              <a:endParaRPr lang="en-US" sz="1000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2444750" y="3867150"/>
              <a:ext cx="21973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Effect of miR-211 mimic on:</a:t>
              </a:r>
              <a:endParaRPr lang="en-US" sz="1400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079500" y="4260850"/>
              <a:ext cx="7008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RAB22A</a:t>
              </a:r>
              <a:endParaRPr lang="en-US" sz="1200" b="1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238500" y="4248150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AP1S2</a:t>
              </a:r>
              <a:endParaRPr lang="en-US" sz="1200" b="1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372100" y="4279900"/>
              <a:ext cx="721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SERINC3</a:t>
              </a:r>
              <a:endParaRPr lang="en-US" sz="1200" b="1" dirty="0"/>
            </a:p>
          </p:txBody>
        </p:sp>
        <p:grpSp>
          <p:nvGrpSpPr>
            <p:cNvPr id="96" name="Group 95"/>
            <p:cNvGrpSpPr/>
            <p:nvPr/>
          </p:nvGrpSpPr>
          <p:grpSpPr>
            <a:xfrm>
              <a:off x="2061428" y="512117"/>
              <a:ext cx="2807732" cy="2520282"/>
              <a:chOff x="2061428" y="683567"/>
              <a:chExt cx="2807732" cy="2520282"/>
            </a:xfrm>
          </p:grpSpPr>
          <p:graphicFrame>
            <p:nvGraphicFramePr>
              <p:cNvPr id="89" name="Chart 88"/>
              <p:cNvGraphicFramePr/>
              <p:nvPr>
                <p:extLst>
                  <p:ext uri="{D42A27DB-BD31-4B8C-83A1-F6EECF244321}">
                    <p14:modId xmlns:p14="http://schemas.microsoft.com/office/powerpoint/2010/main" val="4045982257"/>
                  </p:ext>
                </p:extLst>
              </p:nvPr>
            </p:nvGraphicFramePr>
            <p:xfrm>
              <a:off x="2204864" y="683567"/>
              <a:ext cx="2664296" cy="252028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39" name="TextBox 43"/>
              <p:cNvSpPr txBox="1"/>
              <p:nvPr/>
            </p:nvSpPr>
            <p:spPr>
              <a:xfrm>
                <a:off x="3429000" y="2411760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***</a:t>
                </a:r>
                <a:endParaRPr lang="en-US" sz="500" dirty="0"/>
              </a:p>
            </p:txBody>
          </p:sp>
          <p:sp>
            <p:nvSpPr>
              <p:cNvPr id="140" name="TextBox 43"/>
              <p:cNvSpPr txBox="1"/>
              <p:nvPr/>
            </p:nvSpPr>
            <p:spPr>
              <a:xfrm>
                <a:off x="3230978" y="2339752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***</a:t>
                </a:r>
                <a:endParaRPr lang="en-US" sz="500" dirty="0"/>
              </a:p>
            </p:txBody>
          </p:sp>
          <p:sp>
            <p:nvSpPr>
              <p:cNvPr id="141" name="TextBox 43"/>
              <p:cNvSpPr txBox="1"/>
              <p:nvPr/>
            </p:nvSpPr>
            <p:spPr>
              <a:xfrm>
                <a:off x="2420888" y="1126034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dirty="0" smtClean="0"/>
                  <a:t>***</a:t>
                </a:r>
                <a:endParaRPr lang="en-US" sz="500" dirty="0"/>
              </a:p>
            </p:txBody>
          </p:sp>
          <p:sp>
            <p:nvSpPr>
              <p:cNvPr id="142" name="TextBox 43"/>
              <p:cNvSpPr txBox="1"/>
              <p:nvPr/>
            </p:nvSpPr>
            <p:spPr>
              <a:xfrm>
                <a:off x="3861048" y="2483768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dirty="0" smtClean="0"/>
                  <a:t>***</a:t>
                </a:r>
                <a:endParaRPr lang="en-US" sz="500" dirty="0"/>
              </a:p>
            </p:txBody>
          </p:sp>
          <p:sp>
            <p:nvSpPr>
              <p:cNvPr id="143" name="TextBox 43"/>
              <p:cNvSpPr txBox="1"/>
              <p:nvPr/>
            </p:nvSpPr>
            <p:spPr>
              <a:xfrm>
                <a:off x="4167082" y="2555776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**</a:t>
                </a:r>
                <a:endParaRPr lang="en-US" sz="500" dirty="0"/>
              </a:p>
            </p:txBody>
          </p:sp>
          <p:sp>
            <p:nvSpPr>
              <p:cNvPr id="144" name="TextBox 43"/>
              <p:cNvSpPr txBox="1"/>
              <p:nvPr/>
            </p:nvSpPr>
            <p:spPr>
              <a:xfrm>
                <a:off x="3591018" y="2483768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**</a:t>
                </a:r>
                <a:endParaRPr lang="en-US" sz="500" dirty="0"/>
              </a:p>
            </p:txBody>
          </p:sp>
          <p:sp>
            <p:nvSpPr>
              <p:cNvPr id="145" name="TextBox 43"/>
              <p:cNvSpPr txBox="1"/>
              <p:nvPr/>
            </p:nvSpPr>
            <p:spPr>
              <a:xfrm>
                <a:off x="4311098" y="2555776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ns</a:t>
                </a:r>
                <a:endParaRPr lang="en-US" sz="500" dirty="0"/>
              </a:p>
            </p:txBody>
          </p:sp>
          <p:sp>
            <p:nvSpPr>
              <p:cNvPr id="146" name="TextBox 43"/>
              <p:cNvSpPr txBox="1"/>
              <p:nvPr/>
            </p:nvSpPr>
            <p:spPr>
              <a:xfrm>
                <a:off x="2852936" y="2339752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ns</a:t>
                </a:r>
                <a:endParaRPr lang="en-US" sz="500" dirty="0"/>
              </a:p>
            </p:txBody>
          </p:sp>
          <p:sp>
            <p:nvSpPr>
              <p:cNvPr id="147" name="TextBox 43"/>
              <p:cNvSpPr txBox="1"/>
              <p:nvPr/>
            </p:nvSpPr>
            <p:spPr>
              <a:xfrm>
                <a:off x="2708920" y="1763688"/>
                <a:ext cx="486054" cy="2776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 smtClean="0"/>
                  <a:t>ns</a:t>
                </a:r>
                <a:endParaRPr lang="en-US" sz="5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 rot="16200000">
                <a:off x="1773047" y="1761631"/>
                <a:ext cx="7922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miR-211 levels</a:t>
                </a:r>
                <a:endParaRPr lang="en-US" sz="8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919430" y="2822600"/>
                <a:ext cx="14734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concentration miR-211 mimic</a:t>
                </a:r>
                <a:endParaRPr lang="en-US" sz="800" dirty="0"/>
              </a:p>
            </p:txBody>
          </p:sp>
          <p:sp>
            <p:nvSpPr>
              <p:cNvPr id="93" name="Rectangle 92"/>
              <p:cNvSpPr/>
              <p:nvPr/>
            </p:nvSpPr>
            <p:spPr>
              <a:xfrm>
                <a:off x="3130550" y="2978150"/>
                <a:ext cx="876300" cy="127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7" name="Rectangle 76"/>
            <p:cNvSpPr/>
            <p:nvPr/>
          </p:nvSpPr>
          <p:spPr>
            <a:xfrm>
              <a:off x="3416300" y="6815782"/>
              <a:ext cx="107950" cy="1016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accent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917950" y="6815782"/>
              <a:ext cx="107950" cy="101600"/>
            </a:xfrm>
            <a:prstGeom prst="rect">
              <a:avLst/>
            </a:prstGeom>
            <a:solidFill>
              <a:srgbClr val="00206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2895600" y="6815782"/>
              <a:ext cx="107950" cy="101600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946400" y="6750050"/>
              <a:ext cx="3609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/>
                <a:t>24h</a:t>
              </a:r>
              <a:endParaRPr lang="en-US" sz="9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467100" y="6750050"/>
              <a:ext cx="3626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/>
                <a:t>48h</a:t>
              </a:r>
              <a:endParaRPr lang="en-US" sz="900" b="1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962400" y="6750050"/>
              <a:ext cx="3626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 smtClean="0"/>
                <a:t>72h</a:t>
              </a:r>
              <a:endParaRPr lang="en-US" sz="900" b="1" dirty="0"/>
            </a:p>
          </p:txBody>
        </p:sp>
        <p:sp>
          <p:nvSpPr>
            <p:cNvPr id="98" name="TextBox 97"/>
            <p:cNvSpPr txBox="1"/>
            <p:nvPr/>
          </p:nvSpPr>
          <p:spPr>
            <a:xfrm rot="16200000">
              <a:off x="-222447" y="5404593"/>
              <a:ext cx="994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Relative expression</a:t>
              </a:r>
              <a:endParaRPr lang="en-US" sz="8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870200" y="6445250"/>
              <a:ext cx="15392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/>
                <a:t>Concentration of miR-211 mimic</a:t>
              </a:r>
              <a:endParaRPr lang="en-US" sz="800" dirty="0"/>
            </a:p>
          </p:txBody>
        </p:sp>
        <p:grpSp>
          <p:nvGrpSpPr>
            <p:cNvPr id="148" name="Group 147"/>
            <p:cNvGrpSpPr/>
            <p:nvPr/>
          </p:nvGrpSpPr>
          <p:grpSpPr>
            <a:xfrm>
              <a:off x="484370" y="7010401"/>
              <a:ext cx="2555601" cy="1376520"/>
              <a:chOff x="351020" y="7105651"/>
              <a:chExt cx="2555601" cy="1376520"/>
            </a:xfrm>
          </p:grpSpPr>
          <p:grpSp>
            <p:nvGrpSpPr>
              <p:cNvPr id="100" name="Group 84"/>
              <p:cNvGrpSpPr>
                <a:grpSpLocks/>
              </p:cNvGrpSpPr>
              <p:nvPr/>
            </p:nvGrpSpPr>
            <p:grpSpPr bwMode="auto">
              <a:xfrm>
                <a:off x="355600" y="8013700"/>
                <a:ext cx="1955800" cy="444500"/>
                <a:chOff x="3117850" y="1898650"/>
                <a:chExt cx="2406650" cy="895350"/>
              </a:xfrm>
            </p:grpSpPr>
            <p:pic>
              <p:nvPicPr>
                <p:cNvPr id="101" name="Picture 35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3130550" y="1905000"/>
                  <a:ext cx="2387600" cy="4699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02" name="Picture 36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3130550" y="2349500"/>
                  <a:ext cx="2381250" cy="4445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03" name="Rectangle 102"/>
                <p:cNvSpPr/>
                <p:nvPr/>
              </p:nvSpPr>
              <p:spPr>
                <a:xfrm>
                  <a:off x="3117850" y="1898650"/>
                  <a:ext cx="2406650" cy="888955"/>
                </a:xfrm>
                <a:prstGeom prst="rect">
                  <a:avLst/>
                </a:prstGeom>
                <a:noFill/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/>
                </a:p>
              </p:txBody>
            </p:sp>
            <p:cxnSp>
              <p:nvCxnSpPr>
                <p:cNvPr id="104" name="Straight Connector 103"/>
                <p:cNvCxnSpPr>
                  <a:stCxn id="103" idx="1"/>
                  <a:endCxn id="103" idx="3"/>
                </p:cNvCxnSpPr>
                <p:nvPr/>
              </p:nvCxnSpPr>
              <p:spPr>
                <a:xfrm>
                  <a:off x="3117850" y="2344194"/>
                  <a:ext cx="2406650" cy="0"/>
                </a:xfrm>
                <a:prstGeom prst="line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5" name="Group 61"/>
              <p:cNvGrpSpPr>
                <a:grpSpLocks/>
              </p:cNvGrpSpPr>
              <p:nvPr/>
            </p:nvGrpSpPr>
            <p:grpSpPr bwMode="auto">
              <a:xfrm>
                <a:off x="387350" y="7883525"/>
                <a:ext cx="361950" cy="69850"/>
                <a:chOff x="2438400" y="1025525"/>
                <a:chExt cx="361950" cy="69851"/>
              </a:xfrm>
            </p:grpSpPr>
            <p:cxnSp>
              <p:nvCxnSpPr>
                <p:cNvPr id="106" name="Straight Connector 105"/>
                <p:cNvCxnSpPr/>
                <p:nvPr/>
              </p:nvCxnSpPr>
              <p:spPr>
                <a:xfrm>
                  <a:off x="2438400" y="1028700"/>
                  <a:ext cx="361950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Straight Connector 106"/>
                <p:cNvCxnSpPr/>
                <p:nvPr/>
              </p:nvCxnSpPr>
              <p:spPr>
                <a:xfrm>
                  <a:off x="2795588" y="1025525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Straight Connector 107"/>
                <p:cNvCxnSpPr/>
                <p:nvPr/>
              </p:nvCxnSpPr>
              <p:spPr>
                <a:xfrm>
                  <a:off x="2443163" y="1028700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9" name="Group 62"/>
              <p:cNvGrpSpPr>
                <a:grpSpLocks/>
              </p:cNvGrpSpPr>
              <p:nvPr/>
            </p:nvGrpSpPr>
            <p:grpSpPr bwMode="auto">
              <a:xfrm>
                <a:off x="768350" y="7883525"/>
                <a:ext cx="361950" cy="69850"/>
                <a:chOff x="2438400" y="1025525"/>
                <a:chExt cx="361950" cy="69851"/>
              </a:xfrm>
            </p:grpSpPr>
            <p:cxnSp>
              <p:nvCxnSpPr>
                <p:cNvPr id="111" name="Straight Connector 110"/>
                <p:cNvCxnSpPr/>
                <p:nvPr/>
              </p:nvCxnSpPr>
              <p:spPr>
                <a:xfrm>
                  <a:off x="2438400" y="1028700"/>
                  <a:ext cx="361950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Straight Connector 111"/>
                <p:cNvCxnSpPr/>
                <p:nvPr/>
              </p:nvCxnSpPr>
              <p:spPr>
                <a:xfrm>
                  <a:off x="2795588" y="1025525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Straight Connector 112"/>
                <p:cNvCxnSpPr/>
                <p:nvPr/>
              </p:nvCxnSpPr>
              <p:spPr>
                <a:xfrm>
                  <a:off x="2443163" y="1028700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4" name="Group 67"/>
              <p:cNvGrpSpPr>
                <a:grpSpLocks/>
              </p:cNvGrpSpPr>
              <p:nvPr/>
            </p:nvGrpSpPr>
            <p:grpSpPr bwMode="auto">
              <a:xfrm>
                <a:off x="1155700" y="7883525"/>
                <a:ext cx="361950" cy="69850"/>
                <a:chOff x="2438400" y="1025525"/>
                <a:chExt cx="361950" cy="69851"/>
              </a:xfrm>
            </p:grpSpPr>
            <p:cxnSp>
              <p:nvCxnSpPr>
                <p:cNvPr id="115" name="Straight Connector 114"/>
                <p:cNvCxnSpPr/>
                <p:nvPr/>
              </p:nvCxnSpPr>
              <p:spPr>
                <a:xfrm>
                  <a:off x="2438400" y="1028700"/>
                  <a:ext cx="361950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Straight Connector 115"/>
                <p:cNvCxnSpPr/>
                <p:nvPr/>
              </p:nvCxnSpPr>
              <p:spPr>
                <a:xfrm>
                  <a:off x="2795588" y="1025525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Straight Connector 116"/>
                <p:cNvCxnSpPr/>
                <p:nvPr/>
              </p:nvCxnSpPr>
              <p:spPr>
                <a:xfrm>
                  <a:off x="2443163" y="1028700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8" name="Group 71"/>
              <p:cNvGrpSpPr>
                <a:grpSpLocks/>
              </p:cNvGrpSpPr>
              <p:nvPr/>
            </p:nvGrpSpPr>
            <p:grpSpPr bwMode="auto">
              <a:xfrm>
                <a:off x="1562100" y="7883525"/>
                <a:ext cx="361950" cy="69850"/>
                <a:chOff x="2438400" y="1025525"/>
                <a:chExt cx="361950" cy="69851"/>
              </a:xfrm>
            </p:grpSpPr>
            <p:cxnSp>
              <p:nvCxnSpPr>
                <p:cNvPr id="119" name="Straight Connector 118"/>
                <p:cNvCxnSpPr/>
                <p:nvPr/>
              </p:nvCxnSpPr>
              <p:spPr>
                <a:xfrm>
                  <a:off x="2438400" y="1028700"/>
                  <a:ext cx="361950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Straight Connector 119"/>
                <p:cNvCxnSpPr/>
                <p:nvPr/>
              </p:nvCxnSpPr>
              <p:spPr>
                <a:xfrm>
                  <a:off x="2795588" y="1025525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Connector 120"/>
                <p:cNvCxnSpPr/>
                <p:nvPr/>
              </p:nvCxnSpPr>
              <p:spPr>
                <a:xfrm>
                  <a:off x="2443163" y="1028700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2" name="Group 75"/>
              <p:cNvGrpSpPr>
                <a:grpSpLocks/>
              </p:cNvGrpSpPr>
              <p:nvPr/>
            </p:nvGrpSpPr>
            <p:grpSpPr bwMode="auto">
              <a:xfrm>
                <a:off x="1936750" y="7883525"/>
                <a:ext cx="361950" cy="69850"/>
                <a:chOff x="2438400" y="1025525"/>
                <a:chExt cx="361950" cy="69851"/>
              </a:xfrm>
            </p:grpSpPr>
            <p:cxnSp>
              <p:nvCxnSpPr>
                <p:cNvPr id="123" name="Straight Connector 122"/>
                <p:cNvCxnSpPr/>
                <p:nvPr/>
              </p:nvCxnSpPr>
              <p:spPr>
                <a:xfrm>
                  <a:off x="2438400" y="1028700"/>
                  <a:ext cx="361950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Straight Connector 123"/>
                <p:cNvCxnSpPr/>
                <p:nvPr/>
              </p:nvCxnSpPr>
              <p:spPr>
                <a:xfrm>
                  <a:off x="2795588" y="1025525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2443163" y="1028700"/>
                  <a:ext cx="1587" cy="66676"/>
                </a:xfrm>
                <a:prstGeom prst="line">
                  <a:avLst/>
                </a:prstGeom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6" name="TextBox 22"/>
              <p:cNvSpPr txBox="1">
                <a:spLocks noChangeArrowheads="1"/>
              </p:cNvSpPr>
              <p:nvPr/>
            </p:nvSpPr>
            <p:spPr bwMode="auto">
              <a:xfrm>
                <a:off x="712970" y="7464006"/>
                <a:ext cx="430887" cy="400109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vert27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9pPr>
              </a:lstStyle>
              <a:p>
                <a:pPr eaLnBrk="1" hangingPunct="1">
                  <a:defRPr/>
                </a:pPr>
                <a:r>
                  <a:rPr lang="en-US" sz="800" dirty="0" smtClean="0"/>
                  <a:t>NCM 5nM</a:t>
                </a:r>
              </a:p>
            </p:txBody>
          </p:sp>
          <p:sp>
            <p:nvSpPr>
              <p:cNvPr id="127" name="TextBox 22"/>
              <p:cNvSpPr txBox="1">
                <a:spLocks noChangeArrowheads="1"/>
              </p:cNvSpPr>
              <p:nvPr/>
            </p:nvSpPr>
            <p:spPr bwMode="auto">
              <a:xfrm>
                <a:off x="351020" y="7308851"/>
                <a:ext cx="430887" cy="548914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vert27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9pPr>
              </a:lstStyle>
              <a:p>
                <a:pPr eaLnBrk="1" hangingPunct="1">
                  <a:defRPr/>
                </a:pPr>
                <a:r>
                  <a:rPr lang="en-US" sz="800" dirty="0" smtClean="0"/>
                  <a:t>Untreated ctrl</a:t>
                </a:r>
              </a:p>
            </p:txBody>
          </p:sp>
          <p:sp>
            <p:nvSpPr>
              <p:cNvPr id="128" name="TextBox 22"/>
              <p:cNvSpPr txBox="1">
                <a:spLocks noChangeArrowheads="1"/>
              </p:cNvSpPr>
              <p:nvPr/>
            </p:nvSpPr>
            <p:spPr bwMode="auto">
              <a:xfrm>
                <a:off x="1087620" y="7105651"/>
                <a:ext cx="430887" cy="758464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vert27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9pPr>
              </a:lstStyle>
              <a:p>
                <a:pPr eaLnBrk="1" hangingPunct="1">
                  <a:defRPr/>
                </a:pPr>
                <a:r>
                  <a:rPr lang="en-US" sz="800" dirty="0" smtClean="0"/>
                  <a:t>miR-211 mimic, 5nM</a:t>
                </a:r>
              </a:p>
            </p:txBody>
          </p:sp>
          <p:sp>
            <p:nvSpPr>
              <p:cNvPr id="129" name="TextBox 22"/>
              <p:cNvSpPr txBox="1">
                <a:spLocks noChangeArrowheads="1"/>
              </p:cNvSpPr>
              <p:nvPr/>
            </p:nvSpPr>
            <p:spPr bwMode="auto">
              <a:xfrm>
                <a:off x="1538470" y="7464006"/>
                <a:ext cx="430887" cy="400109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vert27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9pPr>
              </a:lstStyle>
              <a:p>
                <a:pPr eaLnBrk="1" hangingPunct="1">
                  <a:defRPr/>
                </a:pPr>
                <a:r>
                  <a:rPr lang="en-US" sz="800" dirty="0" err="1" smtClean="0"/>
                  <a:t>NCM</a:t>
                </a:r>
                <a:r>
                  <a:rPr lang="en-US" sz="800" dirty="0" smtClean="0"/>
                  <a:t> 10 </a:t>
                </a:r>
                <a:r>
                  <a:rPr lang="en-US" sz="800" dirty="0" err="1" smtClean="0"/>
                  <a:t>nM</a:t>
                </a:r>
                <a:endParaRPr lang="en-US" sz="800" dirty="0" smtClean="0"/>
              </a:p>
            </p:txBody>
          </p:sp>
          <p:sp>
            <p:nvSpPr>
              <p:cNvPr id="130" name="TextBox 22"/>
              <p:cNvSpPr txBox="1">
                <a:spLocks noChangeArrowheads="1"/>
              </p:cNvSpPr>
              <p:nvPr/>
            </p:nvSpPr>
            <p:spPr bwMode="auto">
              <a:xfrm>
                <a:off x="1925820" y="7105651"/>
                <a:ext cx="430887" cy="758464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vert27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cs typeface="Arial" charset="0"/>
                  </a:defRPr>
                </a:lvl9pPr>
              </a:lstStyle>
              <a:p>
                <a:pPr eaLnBrk="1" hangingPunct="1">
                  <a:defRPr/>
                </a:pPr>
                <a:r>
                  <a:rPr lang="en-US" sz="800" dirty="0" err="1" smtClean="0"/>
                  <a:t>miR</a:t>
                </a:r>
                <a:r>
                  <a:rPr lang="en-US" sz="800" dirty="0" smtClean="0"/>
                  <a:t>-211 mimic, 10 </a:t>
                </a:r>
                <a:r>
                  <a:rPr lang="en-US" sz="800" dirty="0" err="1" smtClean="0"/>
                  <a:t>nM</a:t>
                </a:r>
                <a:endParaRPr lang="en-US" sz="800" dirty="0" smtClean="0"/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2292350" y="7975600"/>
                <a:ext cx="6142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 smtClean="0"/>
                  <a:t>RAB22A</a:t>
                </a:r>
                <a:endParaRPr lang="en-US" sz="1000" b="1" dirty="0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2292350" y="8235950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 smtClean="0"/>
                  <a:t>tubulin</a:t>
                </a:r>
                <a:endParaRPr lang="en-US" sz="1000" b="1" dirty="0"/>
              </a:p>
            </p:txBody>
          </p:sp>
        </p:grpSp>
        <p:sp>
          <p:nvSpPr>
            <p:cNvPr id="154" name="Down Arrow 153"/>
            <p:cNvSpPr/>
            <p:nvPr/>
          </p:nvSpPr>
          <p:spPr>
            <a:xfrm>
              <a:off x="1390650" y="6559550"/>
              <a:ext cx="196850" cy="279400"/>
            </a:xfrm>
            <a:prstGeom prst="downArrow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0" name="Group 159"/>
            <p:cNvGrpSpPr/>
            <p:nvPr/>
          </p:nvGrpSpPr>
          <p:grpSpPr>
            <a:xfrm>
              <a:off x="2851150" y="2882900"/>
              <a:ext cx="1429400" cy="230832"/>
              <a:chOff x="2781300" y="3302000"/>
              <a:chExt cx="1429400" cy="230832"/>
            </a:xfrm>
          </p:grpSpPr>
          <p:sp>
            <p:nvSpPr>
              <p:cNvPr id="133" name="Rectangle 132"/>
              <p:cNvSpPr/>
              <p:nvPr/>
            </p:nvSpPr>
            <p:spPr>
              <a:xfrm>
                <a:off x="3302000" y="3367732"/>
                <a:ext cx="107950" cy="101600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5" name="Rectangle 154"/>
              <p:cNvSpPr/>
              <p:nvPr/>
            </p:nvSpPr>
            <p:spPr>
              <a:xfrm>
                <a:off x="3803650" y="3367732"/>
                <a:ext cx="107950" cy="101600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" name="Rectangle 155"/>
              <p:cNvSpPr/>
              <p:nvPr/>
            </p:nvSpPr>
            <p:spPr>
              <a:xfrm>
                <a:off x="2781300" y="3367732"/>
                <a:ext cx="107950" cy="101600"/>
              </a:xfrm>
              <a:prstGeom prst="rect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>
                <a:off x="2832100" y="3302000"/>
                <a:ext cx="36099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 smtClean="0"/>
                  <a:t>24h</a:t>
                </a:r>
                <a:endParaRPr lang="en-US" sz="900" b="1" dirty="0"/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3352800" y="3302000"/>
                <a:ext cx="3626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 smtClean="0"/>
                  <a:t>48h</a:t>
                </a:r>
                <a:endParaRPr lang="en-US" sz="900" b="1" dirty="0"/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3848100" y="3302000"/>
                <a:ext cx="3626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 smtClean="0"/>
                  <a:t>72h</a:t>
                </a:r>
                <a:endParaRPr lang="en-US" sz="900" b="1" dirty="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</TotalTime>
  <Words>83</Words>
  <Application>Microsoft Office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us</dc:creator>
  <cp:lastModifiedBy>Christiane MARGUE</cp:lastModifiedBy>
  <cp:revision>48</cp:revision>
  <dcterms:created xsi:type="dcterms:W3CDTF">2012-06-11T20:01:16Z</dcterms:created>
  <dcterms:modified xsi:type="dcterms:W3CDTF">2013-03-12T09:17:25Z</dcterms:modified>
</cp:coreProperties>
</file>